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26" d="100"/>
          <a:sy n="126" d="100"/>
        </p:scale>
        <p:origin x="-4512" y="-9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60690-0629-F549-B0CA-F171F985BF00}" type="datetimeFigureOut">
              <a:rPr lang="en-US" smtClean="0"/>
              <a:t>18/0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B8236-1DDA-E44C-AEBE-BDDBF34C2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160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60690-0629-F549-B0CA-F171F985BF00}" type="datetimeFigureOut">
              <a:rPr lang="en-US" smtClean="0"/>
              <a:t>18/0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B8236-1DDA-E44C-AEBE-BDDBF34C2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7126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60690-0629-F549-B0CA-F171F985BF00}" type="datetimeFigureOut">
              <a:rPr lang="en-US" smtClean="0"/>
              <a:t>18/0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B8236-1DDA-E44C-AEBE-BDDBF34C2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7377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60690-0629-F549-B0CA-F171F985BF00}" type="datetimeFigureOut">
              <a:rPr lang="en-US" smtClean="0"/>
              <a:t>18/0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B8236-1DDA-E44C-AEBE-BDDBF34C2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353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60690-0629-F549-B0CA-F171F985BF00}" type="datetimeFigureOut">
              <a:rPr lang="en-US" smtClean="0"/>
              <a:t>18/0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B8236-1DDA-E44C-AEBE-BDDBF34C2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079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60690-0629-F549-B0CA-F171F985BF00}" type="datetimeFigureOut">
              <a:rPr lang="en-US" smtClean="0"/>
              <a:t>18/0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B8236-1DDA-E44C-AEBE-BDDBF34C2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276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60690-0629-F549-B0CA-F171F985BF00}" type="datetimeFigureOut">
              <a:rPr lang="en-US" smtClean="0"/>
              <a:t>18/0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B8236-1DDA-E44C-AEBE-BDDBF34C2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4992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60690-0629-F549-B0CA-F171F985BF00}" type="datetimeFigureOut">
              <a:rPr lang="en-US" smtClean="0"/>
              <a:t>18/0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B8236-1DDA-E44C-AEBE-BDDBF34C2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65639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60690-0629-F549-B0CA-F171F985BF00}" type="datetimeFigureOut">
              <a:rPr lang="en-US" smtClean="0"/>
              <a:t>18/0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B8236-1DDA-E44C-AEBE-BDDBF34C2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032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60690-0629-F549-B0CA-F171F985BF00}" type="datetimeFigureOut">
              <a:rPr lang="en-US" smtClean="0"/>
              <a:t>18/0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B8236-1DDA-E44C-AEBE-BDDBF34C2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7312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60690-0629-F549-B0CA-F171F985BF00}" type="datetimeFigureOut">
              <a:rPr lang="en-US" smtClean="0"/>
              <a:t>18/0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B8236-1DDA-E44C-AEBE-BDDBF34C2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8634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B60690-0629-F549-B0CA-F171F985BF00}" type="datetimeFigureOut">
              <a:rPr lang="en-US" smtClean="0"/>
              <a:t>18/0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7B8236-1DDA-E44C-AEBE-BDDBF34C2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72334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Normalised graph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5537" y="1115348"/>
            <a:ext cx="4075964" cy="4015310"/>
          </a:xfrm>
          <a:prstGeom prst="rect">
            <a:avLst/>
          </a:prstGeom>
        </p:spPr>
      </p:pic>
      <p:cxnSp>
        <p:nvCxnSpPr>
          <p:cNvPr id="6" name="Straight Arrow Connector 5"/>
          <p:cNvCxnSpPr/>
          <p:nvPr/>
        </p:nvCxnSpPr>
        <p:spPr>
          <a:xfrm flipV="1">
            <a:off x="2927943" y="4021873"/>
            <a:ext cx="473747" cy="40319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 flipH="1">
            <a:off x="3468634" y="3146124"/>
            <a:ext cx="473747" cy="40319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 flipH="1">
            <a:off x="3642398" y="3429562"/>
            <a:ext cx="473747" cy="40319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3126372" y="2700978"/>
            <a:ext cx="1632018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Affected individual</a:t>
            </a:r>
          </a:p>
          <a:p>
            <a:pPr algn="ctr"/>
            <a:r>
              <a:rPr lang="en-US" sz="1200" dirty="0" smtClean="0"/>
              <a:t> – maternal duplication</a:t>
            </a:r>
            <a:endParaRPr lang="en-US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1276520" y="4194235"/>
            <a:ext cx="1632018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Unaffected mother</a:t>
            </a:r>
          </a:p>
          <a:p>
            <a:pPr algn="ctr"/>
            <a:r>
              <a:rPr lang="en-US" sz="1200" dirty="0" smtClean="0"/>
              <a:t> – paternal duplication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4116145" y="3371092"/>
            <a:ext cx="1632018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Unaffected father</a:t>
            </a:r>
          </a:p>
          <a:p>
            <a:pPr algn="ctr"/>
            <a:r>
              <a:rPr lang="en-US" sz="1200" dirty="0" smtClean="0"/>
              <a:t> – no duplication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0503463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8</Words>
  <Application>Microsoft Macintosh PowerPoint</Application>
  <PresentationFormat>A4 Paper (210x297 mm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ardiff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Isles</dc:creator>
  <cp:lastModifiedBy>Anthony Isles</cp:lastModifiedBy>
  <cp:revision>1</cp:revision>
  <dcterms:created xsi:type="dcterms:W3CDTF">2015-02-18T17:57:47Z</dcterms:created>
  <dcterms:modified xsi:type="dcterms:W3CDTF">2015-02-18T18:04:09Z</dcterms:modified>
</cp:coreProperties>
</file>